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60" d="100"/>
          <a:sy n="60" d="100"/>
        </p:scale>
        <p:origin x="-1296" y="-7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6F258D-FE8F-4CD4-BA61-D35B55000360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C9ABF7-AF3F-43BE-BB81-04AA0532E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8256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S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9ABF7-AF3F-43BE-BB81-04AA0532E92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628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5779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399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043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7787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1691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1519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8779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167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9750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0002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1845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4E800-A1AE-4A90-92D7-42AFE7E84100}" type="datetimeFigureOut">
              <a:rPr lang="en-GB" smtClean="0"/>
              <a:t>18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5BFF5B-A894-4A97-BE04-286DC95E24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005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018" y="44624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4194" y="44624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4" name="Picture 1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8370" y="44624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6256" y="39266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6" name="Picture 1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2080" y="49138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579767" y="1419413"/>
            <a:ext cx="5468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a) Bland Altman plots of invasive proportional wave intensities</a:t>
            </a:r>
            <a:endParaRPr lang="en-GB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799530" y="99552"/>
            <a:ext cx="5249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FCW</a:t>
            </a:r>
            <a:endParaRPr lang="en-GB" sz="1100" dirty="0"/>
          </a:p>
        </p:txBody>
      </p:sp>
      <p:sp>
        <p:nvSpPr>
          <p:cNvPr id="41" name="TextBox 40"/>
          <p:cNvSpPr txBox="1"/>
          <p:nvPr/>
        </p:nvSpPr>
        <p:spPr>
          <a:xfrm>
            <a:off x="2339752" y="71046"/>
            <a:ext cx="517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FEW</a:t>
            </a:r>
            <a:endParaRPr lang="en-GB" sz="1100" dirty="0"/>
          </a:p>
        </p:txBody>
      </p:sp>
      <p:sp>
        <p:nvSpPr>
          <p:cNvPr id="42" name="TextBox 41"/>
          <p:cNvSpPr txBox="1"/>
          <p:nvPr/>
        </p:nvSpPr>
        <p:spPr>
          <a:xfrm>
            <a:off x="3890763" y="99552"/>
            <a:ext cx="6092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FCW2</a:t>
            </a:r>
            <a:endParaRPr lang="en-GB" sz="1100" dirty="0"/>
          </a:p>
        </p:txBody>
      </p:sp>
      <p:sp>
        <p:nvSpPr>
          <p:cNvPr id="43" name="TextBox 42"/>
          <p:cNvSpPr txBox="1"/>
          <p:nvPr/>
        </p:nvSpPr>
        <p:spPr>
          <a:xfrm>
            <a:off x="5508104" y="112943"/>
            <a:ext cx="5399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BCW</a:t>
            </a:r>
            <a:endParaRPr lang="en-GB" sz="1100" dirty="0"/>
          </a:p>
        </p:txBody>
      </p:sp>
      <p:sp>
        <p:nvSpPr>
          <p:cNvPr id="59" name="TextBox 58"/>
          <p:cNvSpPr txBox="1"/>
          <p:nvPr/>
        </p:nvSpPr>
        <p:spPr>
          <a:xfrm>
            <a:off x="7092280" y="87891"/>
            <a:ext cx="5324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BEW</a:t>
            </a:r>
            <a:endParaRPr lang="en-GB" sz="1100" dirty="0"/>
          </a:p>
        </p:txBody>
      </p:sp>
      <p:sp>
        <p:nvSpPr>
          <p:cNvPr id="50" name="TextBox 49"/>
          <p:cNvSpPr txBox="1"/>
          <p:nvPr/>
        </p:nvSpPr>
        <p:spPr>
          <a:xfrm>
            <a:off x="611560" y="5193934"/>
            <a:ext cx="61585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c) Bland Altman plots of invasive vs CMR proportional wave intensities</a:t>
            </a:r>
            <a:endParaRPr lang="en-GB" sz="1400" dirty="0"/>
          </a:p>
        </p:txBody>
      </p:sp>
      <p:sp>
        <p:nvSpPr>
          <p:cNvPr id="70" name="Right Arrow 69"/>
          <p:cNvSpPr/>
          <p:nvPr/>
        </p:nvSpPr>
        <p:spPr>
          <a:xfrm>
            <a:off x="2555776" y="5584069"/>
            <a:ext cx="3664168" cy="13987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ight Arrow 71"/>
          <p:cNvSpPr/>
          <p:nvPr/>
        </p:nvSpPr>
        <p:spPr>
          <a:xfrm rot="16200000">
            <a:off x="-434942" y="4306705"/>
            <a:ext cx="1584234" cy="152334"/>
          </a:xfrm>
          <a:prstGeom prst="rightArrow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448" y="3717032"/>
            <a:ext cx="157728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728" y="3717032"/>
            <a:ext cx="157728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3467" y="3715969"/>
            <a:ext cx="157728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1614" y="3698804"/>
            <a:ext cx="157728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3152" y="3686097"/>
            <a:ext cx="157728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07002" y="1753306"/>
            <a:ext cx="6703440" cy="1210131"/>
          </a:xfrm>
        </p:spPr>
        <p:txBody>
          <a:bodyPr/>
          <a:lstStyle/>
          <a:p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79342" y="3824497"/>
            <a:ext cx="5520480" cy="1442748"/>
          </a:xfrm>
        </p:spPr>
        <p:txBody>
          <a:bodyPr/>
          <a:lstStyle/>
          <a:p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51" name="TextBox 50"/>
          <p:cNvSpPr txBox="1"/>
          <p:nvPr/>
        </p:nvSpPr>
        <p:spPr>
          <a:xfrm>
            <a:off x="2911049" y="3452256"/>
            <a:ext cx="3070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First measure of wave intensity (%)</a:t>
            </a:r>
            <a:endParaRPr lang="en-GB" sz="12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-1061191" y="1125058"/>
            <a:ext cx="25126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Difference between first and second measures of wave intensity (%)</a:t>
            </a:r>
            <a:endParaRPr lang="en-GB" sz="1200" dirty="0"/>
          </a:p>
        </p:txBody>
      </p:sp>
      <p:sp>
        <p:nvSpPr>
          <p:cNvPr id="53" name="Right Arrow 52"/>
          <p:cNvSpPr/>
          <p:nvPr/>
        </p:nvSpPr>
        <p:spPr>
          <a:xfrm rot="16200000">
            <a:off x="-852271" y="1497137"/>
            <a:ext cx="2633039" cy="152330"/>
          </a:xfrm>
          <a:prstGeom prst="rightArrow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/>
          <p:cNvSpPr txBox="1"/>
          <p:nvPr/>
        </p:nvSpPr>
        <p:spPr>
          <a:xfrm>
            <a:off x="3185630" y="5672281"/>
            <a:ext cx="2250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Invasive wave intensity (%)</a:t>
            </a:r>
            <a:endParaRPr lang="en-GB" sz="12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-1076870" y="3766037"/>
            <a:ext cx="2512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CMR wave intensity (%)</a:t>
            </a:r>
            <a:endParaRPr lang="en-GB" sz="1200" dirty="0"/>
          </a:p>
        </p:txBody>
      </p:sp>
      <p:sp>
        <p:nvSpPr>
          <p:cNvPr id="74" name="Right Arrow 73"/>
          <p:cNvSpPr/>
          <p:nvPr/>
        </p:nvSpPr>
        <p:spPr>
          <a:xfrm>
            <a:off x="2549602" y="3376208"/>
            <a:ext cx="3664168" cy="13987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87" name="Picture 15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018" y="1727190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8" name="Picture 16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4194" y="1700808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9" name="Picture 17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7904" y="1700808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90" name="Picture 18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2080" y="1717846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91" name="Picture 19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6256" y="1700808"/>
            <a:ext cx="1593710" cy="1495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565368" y="3068431"/>
            <a:ext cx="4654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b) Bland Altman plots of CMR proportional wave intensities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557522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69</Words>
  <Application>Microsoft Office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 </vt:lpstr>
    </vt:vector>
  </TitlesOfParts>
  <Company>RBH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egan Jenny</dc:creator>
  <cp:lastModifiedBy>Claire E Raphael</cp:lastModifiedBy>
  <cp:revision>23</cp:revision>
  <dcterms:created xsi:type="dcterms:W3CDTF">2016-11-08T13:01:52Z</dcterms:created>
  <dcterms:modified xsi:type="dcterms:W3CDTF">2016-11-18T15:42:44Z</dcterms:modified>
</cp:coreProperties>
</file>